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63A1FD-B401-4E91-A991-41EF00985AE2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9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90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it-IT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1" name="Segnaposto numero diapositiva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242151-90BA-4450-B2B7-F10BDD29B5A1}" type="slidenum">
              <a:rPr b="0" lang="it-IT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01D0CB-4B86-4B7E-B90C-FD6419151BD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81F65A-5266-4FCA-AADE-7C84302AAA6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0B1CB35-89B0-4499-A621-2B5C087093E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970651-B3DD-4F56-94ED-47D5D3D9147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166F22-4925-4A03-B6E8-8F67DB9EB39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5851BDF-5149-4D7E-AE3C-7610A4B073E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E0C1D1-81E5-47D0-BDA0-D83D29D1B11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B76CC7-AC9A-4109-8F6A-0783A5CD75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D45CB7-D322-45D7-9826-3A961430665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9131115-B0B3-4CC3-AF84-A34F3BA9837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AD9B15-26CC-42D6-AB98-8CC828B260E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2617D5-209C-46FC-9A6C-9F399AECBF1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it-IT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CD10BA72-5DAB-4686-86CD-48C28A9748A1}" type="slidenum">
              <a:rPr b="0" lang="it-IT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slideLayout" Target="../slideLayouts/slideLayout1.xml"/><Relationship Id="rId3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Immagine 3" descr="ELISA.jpg"/>
          <p:cNvPicPr/>
          <p:nvPr/>
        </p:nvPicPr>
        <p:blipFill>
          <a:blip r:embed="rId1">
            <a:lum bright="10000"/>
          </a:blip>
          <a:stretch/>
        </p:blipFill>
        <p:spPr>
          <a:xfrm>
            <a:off x="2071800" y="1071720"/>
            <a:ext cx="4408200" cy="2928960"/>
          </a:xfrm>
          <a:prstGeom prst="rect">
            <a:avLst/>
          </a:prstGeom>
          <a:ln w="0">
            <a:noFill/>
          </a:ln>
        </p:spPr>
      </p:pic>
      <p:sp>
        <p:nvSpPr>
          <p:cNvPr id="49" name="CasellaDiTesto 4"/>
          <p:cNvSpPr/>
          <p:nvPr/>
        </p:nvSpPr>
        <p:spPr>
          <a:xfrm>
            <a:off x="2060280" y="1300320"/>
            <a:ext cx="35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H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0" name="CasellaDiTesto 5"/>
          <p:cNvSpPr/>
          <p:nvPr/>
        </p:nvSpPr>
        <p:spPr>
          <a:xfrm>
            <a:off x="2063520" y="1600200"/>
            <a:ext cx="35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H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CasellaDiTesto 7"/>
          <p:cNvSpPr/>
          <p:nvPr/>
        </p:nvSpPr>
        <p:spPr>
          <a:xfrm>
            <a:off x="1886040" y="191448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Pre-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CasellaDiTesto 8"/>
          <p:cNvSpPr/>
          <p:nvPr/>
        </p:nvSpPr>
        <p:spPr>
          <a:xfrm>
            <a:off x="1820160" y="222264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Post-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CasellaDiTesto 9"/>
          <p:cNvSpPr/>
          <p:nvPr/>
        </p:nvSpPr>
        <p:spPr>
          <a:xfrm>
            <a:off x="2051280" y="2541600"/>
            <a:ext cx="37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CP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CasellaDiTesto 10"/>
          <p:cNvSpPr/>
          <p:nvPr/>
        </p:nvSpPr>
        <p:spPr>
          <a:xfrm>
            <a:off x="1535760" y="2852640"/>
            <a:ext cx="90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serum+ Ig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CasellaDiTesto 11"/>
          <p:cNvSpPr/>
          <p:nvPr/>
        </p:nvSpPr>
        <p:spPr>
          <a:xfrm>
            <a:off x="1379880" y="3186000"/>
            <a:ext cx="107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serum+ 5-AS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CasellaDiTesto 12"/>
          <p:cNvSpPr/>
          <p:nvPr/>
        </p:nvSpPr>
        <p:spPr>
          <a:xfrm>
            <a:off x="1495800" y="3506760"/>
            <a:ext cx="91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IgG + 5-AS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CasellaDiTesto 13"/>
          <p:cNvSpPr/>
          <p:nvPr/>
        </p:nvSpPr>
        <p:spPr>
          <a:xfrm rot="16200000">
            <a:off x="2277000" y="916560"/>
            <a:ext cx="45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CasellaDiTesto 14"/>
          <p:cNvSpPr/>
          <p:nvPr/>
        </p:nvSpPr>
        <p:spPr>
          <a:xfrm rot="16200000">
            <a:off x="2597760" y="925920"/>
            <a:ext cx="45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CasellaDiTesto 15"/>
          <p:cNvSpPr/>
          <p:nvPr/>
        </p:nvSpPr>
        <p:spPr>
          <a:xfrm rot="16200000">
            <a:off x="2903400" y="903960"/>
            <a:ext cx="53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CasellaDiTesto 16"/>
          <p:cNvSpPr/>
          <p:nvPr/>
        </p:nvSpPr>
        <p:spPr>
          <a:xfrm rot="16200000">
            <a:off x="3190680" y="906120"/>
            <a:ext cx="53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CasellaDiTesto 17"/>
          <p:cNvSpPr/>
          <p:nvPr/>
        </p:nvSpPr>
        <p:spPr>
          <a:xfrm rot="16200000">
            <a:off x="3525480" y="906120"/>
            <a:ext cx="53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CasellaDiTesto 18"/>
          <p:cNvSpPr/>
          <p:nvPr/>
        </p:nvSpPr>
        <p:spPr>
          <a:xfrm rot="16200000">
            <a:off x="3847680" y="906120"/>
            <a:ext cx="53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8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CasellaDiTesto 19"/>
          <p:cNvSpPr/>
          <p:nvPr/>
        </p:nvSpPr>
        <p:spPr>
          <a:xfrm rot="16200000">
            <a:off x="4112280" y="86040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1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CasellaDiTesto 20"/>
          <p:cNvSpPr/>
          <p:nvPr/>
        </p:nvSpPr>
        <p:spPr>
          <a:xfrm rot="16200000">
            <a:off x="4434480" y="86184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3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CasellaDiTesto 21"/>
          <p:cNvSpPr/>
          <p:nvPr/>
        </p:nvSpPr>
        <p:spPr>
          <a:xfrm rot="16200000">
            <a:off x="4732920" y="86184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6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CasellaDiTesto 22"/>
          <p:cNvSpPr/>
          <p:nvPr/>
        </p:nvSpPr>
        <p:spPr>
          <a:xfrm rot="16200000">
            <a:off x="5016240" y="824400"/>
            <a:ext cx="68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128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67" name=""/>
          <p:cNvGraphicFramePr/>
          <p:nvPr/>
        </p:nvGraphicFramePr>
        <p:xfrm>
          <a:off x="2143080" y="4780080"/>
          <a:ext cx="4286160" cy="936360"/>
        </p:xfrm>
        <a:graphic>
          <a:graphicData uri="http://schemas.openxmlformats.org/drawingml/2006/table">
            <a:tbl>
              <a:tblPr/>
              <a:tblGrid>
                <a:gridCol w="428760"/>
                <a:gridCol w="428400"/>
                <a:gridCol w="428760"/>
                <a:gridCol w="428760"/>
                <a:gridCol w="428400"/>
                <a:gridCol w="428760"/>
                <a:gridCol w="428760"/>
                <a:gridCol w="428400"/>
                <a:gridCol w="428760"/>
                <a:gridCol w="428400"/>
              </a:tblGrid>
              <a:tr h="231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4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9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1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4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5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2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4300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2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9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7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112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3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4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14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59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33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28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6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87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68" name=""/>
          <p:cNvGraphicFramePr/>
          <p:nvPr/>
        </p:nvGraphicFramePr>
        <p:xfrm>
          <a:off x="2141640" y="5718240"/>
          <a:ext cx="858600" cy="923760"/>
        </p:xfrm>
        <a:graphic>
          <a:graphicData uri="http://schemas.openxmlformats.org/drawingml/2006/table">
            <a:tbl>
              <a:tblPr/>
              <a:tblGrid>
                <a:gridCol w="428400"/>
                <a:gridCol w="430200"/>
              </a:tblGrid>
              <a:tr h="2311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188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43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11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1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5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11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76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6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3112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29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it-IT" sz="900" spc="-1" strike="noStrike">
                          <a:solidFill>
                            <a:srgbClr val="000000"/>
                          </a:solidFill>
                          <a:latin typeface="Calibri"/>
                        </a:rPr>
                        <a:t>100</a:t>
                      </a:r>
                      <a:endParaRPr b="0" lang="en-US" sz="9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69" name="CasellaDiTesto 32"/>
          <p:cNvSpPr/>
          <p:nvPr/>
        </p:nvSpPr>
        <p:spPr>
          <a:xfrm rot="16200000">
            <a:off x="2124720" y="4458240"/>
            <a:ext cx="45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1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0" name="CasellaDiTesto 33"/>
          <p:cNvSpPr/>
          <p:nvPr/>
        </p:nvSpPr>
        <p:spPr>
          <a:xfrm rot="16200000">
            <a:off x="2562840" y="4469400"/>
            <a:ext cx="4564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5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CasellaDiTesto 34"/>
          <p:cNvSpPr/>
          <p:nvPr/>
        </p:nvSpPr>
        <p:spPr>
          <a:xfrm rot="16200000">
            <a:off x="2928600" y="4447080"/>
            <a:ext cx="53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1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CasellaDiTesto 35"/>
          <p:cNvSpPr/>
          <p:nvPr/>
        </p:nvSpPr>
        <p:spPr>
          <a:xfrm rot="16200000">
            <a:off x="3381120" y="4448880"/>
            <a:ext cx="53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CasellaDiTesto 36"/>
          <p:cNvSpPr/>
          <p:nvPr/>
        </p:nvSpPr>
        <p:spPr>
          <a:xfrm rot="16200000">
            <a:off x="3809880" y="4448880"/>
            <a:ext cx="53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CasellaDiTesto 37"/>
          <p:cNvSpPr/>
          <p:nvPr/>
        </p:nvSpPr>
        <p:spPr>
          <a:xfrm rot="16200000">
            <a:off x="4238280" y="4448880"/>
            <a:ext cx="5342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8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5" name="CasellaDiTesto 38"/>
          <p:cNvSpPr/>
          <p:nvPr/>
        </p:nvSpPr>
        <p:spPr>
          <a:xfrm rot="16200000">
            <a:off x="4628160" y="440352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16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CasellaDiTesto 39"/>
          <p:cNvSpPr/>
          <p:nvPr/>
        </p:nvSpPr>
        <p:spPr>
          <a:xfrm rot="16200000">
            <a:off x="5056560" y="440532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32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CasellaDiTesto 40"/>
          <p:cNvSpPr/>
          <p:nvPr/>
        </p:nvSpPr>
        <p:spPr>
          <a:xfrm rot="16200000">
            <a:off x="5483880" y="4405320"/>
            <a:ext cx="61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64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CasellaDiTesto 41"/>
          <p:cNvSpPr/>
          <p:nvPr/>
        </p:nvSpPr>
        <p:spPr>
          <a:xfrm rot="16200000">
            <a:off x="5838480" y="4353480"/>
            <a:ext cx="6897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1:12800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CasellaDiTesto 42"/>
          <p:cNvSpPr/>
          <p:nvPr/>
        </p:nvSpPr>
        <p:spPr>
          <a:xfrm>
            <a:off x="1879200" y="4735440"/>
            <a:ext cx="35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H1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CasellaDiTesto 43"/>
          <p:cNvSpPr/>
          <p:nvPr/>
        </p:nvSpPr>
        <p:spPr>
          <a:xfrm>
            <a:off x="1882440" y="4992840"/>
            <a:ext cx="3546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H2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CasellaDiTesto 44"/>
          <p:cNvSpPr/>
          <p:nvPr/>
        </p:nvSpPr>
        <p:spPr>
          <a:xfrm>
            <a:off x="1645560" y="5259240"/>
            <a:ext cx="529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Pre-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2" name="CasellaDiTesto 45"/>
          <p:cNvSpPr/>
          <p:nvPr/>
        </p:nvSpPr>
        <p:spPr>
          <a:xfrm>
            <a:off x="1580400" y="5497560"/>
            <a:ext cx="5950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Post-V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3" name="CasellaDiTesto 46"/>
          <p:cNvSpPr/>
          <p:nvPr/>
        </p:nvSpPr>
        <p:spPr>
          <a:xfrm>
            <a:off x="1834560" y="5710320"/>
            <a:ext cx="37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CP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4" name="CasellaDiTesto 47"/>
          <p:cNvSpPr/>
          <p:nvPr/>
        </p:nvSpPr>
        <p:spPr>
          <a:xfrm>
            <a:off x="1284120" y="5948280"/>
            <a:ext cx="900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serum+ IgG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5" name="CasellaDiTesto 48"/>
          <p:cNvSpPr/>
          <p:nvPr/>
        </p:nvSpPr>
        <p:spPr>
          <a:xfrm>
            <a:off x="1102680" y="6164280"/>
            <a:ext cx="107244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serum+ 5-AS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6" name="CasellaDiTesto 49"/>
          <p:cNvSpPr/>
          <p:nvPr/>
        </p:nvSpPr>
        <p:spPr>
          <a:xfrm>
            <a:off x="1279800" y="6426360"/>
            <a:ext cx="9198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200" spc="-1" strike="noStrike">
                <a:solidFill>
                  <a:srgbClr val="000000"/>
                </a:solidFill>
                <a:latin typeface="Calibri"/>
              </a:rPr>
              <a:t>IgG + 5-AS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7" name="CasellaDiTesto 50"/>
          <p:cNvSpPr/>
          <p:nvPr/>
        </p:nvSpPr>
        <p:spPr>
          <a:xfrm>
            <a:off x="6855480" y="2016000"/>
            <a:ext cx="1761120" cy="115956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</a:rPr>
              <a:t>H1: healthy donor 1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</a:rPr>
              <a:t>H2: healthy donor 2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</a:rPr>
              <a:t>Pre-V: before vacci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</a:rPr>
              <a:t>Post-V: post vaccine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1400" spc="-1" strike="noStrike">
                <a:solidFill>
                  <a:srgbClr val="000000"/>
                </a:solidFill>
                <a:latin typeface="Calibri"/>
              </a:rPr>
              <a:t>CP: positive control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8" name="Rectangle 115"/>
          <p:cNvSpPr/>
          <p:nvPr/>
        </p:nvSpPr>
        <p:spPr>
          <a:xfrm>
            <a:off x="255600" y="2160"/>
            <a:ext cx="8033760" cy="611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ctr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  <a:ea typeface="Calibri"/>
              </a:rPr>
              <a:t>Figure S1. 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 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Measurement of p17 antibodies in the  serum  of  healthy donors (H1 and H2) and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  <a:p>
            <a:pPr algn="just">
              <a:lnSpc>
                <a:spcPct val="100000"/>
              </a:lnSpc>
              <a:tabLst>
                <a:tab algn="l" pos="0"/>
                <a:tab algn="l" pos="581040"/>
                <a:tab algn="l" pos="1163520"/>
                <a:tab algn="l" pos="1744560"/>
                <a:tab algn="l" pos="2327400"/>
                <a:tab algn="l" pos="2908440"/>
                <a:tab algn="l" pos="3489480"/>
                <a:tab algn="l" pos="4071960"/>
                <a:tab algn="l" pos="4653000"/>
                <a:tab algn="l" pos="5235480"/>
                <a:tab algn="l" pos="5816520"/>
                <a:tab algn="l" pos="6397560"/>
                <a:tab algn="l" pos="6980400"/>
                <a:tab algn="l" pos="7561440"/>
                <a:tab algn="l" pos="8143920"/>
                <a:tab algn="l" pos="8724960"/>
                <a:tab algn="l" pos="9306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 </a:t>
            </a:r>
            <a:r>
              <a:rPr b="0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HIV infected  patient before  and after vaccination with a anti-p17 vaccine (pre-V and post-V).</a:t>
            </a:r>
            <a:r>
              <a:rPr b="1" lang="en-US" sz="1600" spc="-1" strike="noStrike">
                <a:solidFill>
                  <a:srgbClr val="000000"/>
                </a:solidFill>
                <a:latin typeface="Calibri"/>
                <a:ea typeface="Calibri"/>
              </a:rPr>
              <a:t>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95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11-11T16:09:56Z</dcterms:created>
  <dc:creator>pc3</dc:creator>
  <dc:description/>
  <dc:language>en-US</dc:language>
  <cp:lastModifiedBy> </cp:lastModifiedBy>
  <dcterms:modified xsi:type="dcterms:W3CDTF">2012-01-27T11:28:11Z</dcterms:modified>
  <cp:revision>2</cp:revision>
  <dc:subject/>
  <dc:title>Diapositiva 1</dc:title>
</cp:coreProperties>
</file>